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  <a:srgbClr val="953735"/>
    <a:srgbClr val="D9969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543" autoAdjust="0"/>
  </p:normalViewPr>
  <p:slideViewPr>
    <p:cSldViewPr snapToGrid="0">
      <p:cViewPr>
        <p:scale>
          <a:sx n="170" d="100"/>
          <a:sy n="170" d="100"/>
        </p:scale>
        <p:origin x="-1302" y="-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8E0A08-3BAE-41ED-82C3-9CD964C4F256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4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13DDBE-9BA8-42BF-95F2-8C36EDDD2E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225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13DDBE-9BA8-42BF-95F2-8C36EDDD2EE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27005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864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6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631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12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79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782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978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324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6890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4229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850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1FC8C-8076-474B-912A-24C31F53ECFE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59951-9898-4ECC-B1F1-4F652B85C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451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42285" y="1341739"/>
            <a:ext cx="9468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Alox5ap (705bp)</a:t>
            </a:r>
            <a:endParaRPr lang="en-GB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2932811" y="757507"/>
            <a:ext cx="1096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Promoter regions</a:t>
            </a:r>
            <a:endParaRPr lang="en-GB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121813" y="1840365"/>
            <a:ext cx="9658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Mcpt1 (606bp)</a:t>
            </a:r>
            <a:endParaRPr lang="en-GB" sz="800" dirty="0"/>
          </a:p>
        </p:txBody>
      </p:sp>
      <p:sp>
        <p:nvSpPr>
          <p:cNvPr id="14" name="TextBox 13"/>
          <p:cNvSpPr txBox="1"/>
          <p:nvPr/>
        </p:nvSpPr>
        <p:spPr>
          <a:xfrm>
            <a:off x="394768" y="1585875"/>
            <a:ext cx="692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err="1" smtClean="0"/>
              <a:t>Nts</a:t>
            </a:r>
            <a:r>
              <a:rPr lang="en-GB" sz="800" dirty="0" smtClean="0"/>
              <a:t> (793bp)</a:t>
            </a:r>
            <a:endParaRPr lang="en-GB" sz="800" dirty="0"/>
          </a:p>
        </p:txBody>
      </p:sp>
      <p:sp>
        <p:nvSpPr>
          <p:cNvPr id="15" name="TextBox 14"/>
          <p:cNvSpPr txBox="1"/>
          <p:nvPr/>
        </p:nvSpPr>
        <p:spPr>
          <a:xfrm>
            <a:off x="192730" y="1091393"/>
            <a:ext cx="8835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800" dirty="0" smtClean="0"/>
              <a:t>Cyp2c66 (613bp)</a:t>
            </a:r>
            <a:endParaRPr lang="en-GB" sz="8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1038034" y="953411"/>
            <a:ext cx="4543200" cy="249842"/>
            <a:chOff x="1080000" y="871672"/>
            <a:chExt cx="4543200" cy="249842"/>
          </a:xfrm>
        </p:grpSpPr>
        <p:grpSp>
          <p:nvGrpSpPr>
            <p:cNvPr id="17" name="Group 16"/>
            <p:cNvGrpSpPr/>
            <p:nvPr/>
          </p:nvGrpSpPr>
          <p:grpSpPr>
            <a:xfrm>
              <a:off x="1080000" y="1013792"/>
              <a:ext cx="4543200" cy="107722"/>
              <a:chOff x="1080000" y="1013792"/>
              <a:chExt cx="4543200" cy="107722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 flipV="1">
                <a:off x="1080000" y="1119296"/>
                <a:ext cx="4543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flipV="1">
                <a:off x="4024800" y="1013792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/>
            <p:cNvSpPr txBox="1"/>
            <p:nvPr/>
          </p:nvSpPr>
          <p:spPr>
            <a:xfrm>
              <a:off x="3900407" y="871672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1044858" y="1206226"/>
            <a:ext cx="5076000" cy="246927"/>
            <a:chOff x="1080000" y="1124487"/>
            <a:chExt cx="5076000" cy="246927"/>
          </a:xfrm>
        </p:grpSpPr>
        <p:grpSp>
          <p:nvGrpSpPr>
            <p:cNvPr id="22" name="Group 21"/>
            <p:cNvGrpSpPr/>
            <p:nvPr/>
          </p:nvGrpSpPr>
          <p:grpSpPr>
            <a:xfrm flipH="1" flipV="1">
              <a:off x="1080000" y="1260000"/>
              <a:ext cx="5076000" cy="109354"/>
              <a:chOff x="1440000" y="1656000"/>
              <a:chExt cx="5076000" cy="109354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1440000" y="1656000"/>
                <a:ext cx="50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1764000" y="1657632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2001600" y="1657104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2282400" y="1657104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2592000" y="1657104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TextBox 22"/>
            <p:cNvSpPr txBox="1"/>
            <p:nvPr/>
          </p:nvSpPr>
          <p:spPr>
            <a:xfrm>
              <a:off x="4877497" y="1125193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187141" y="112448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468525" y="112448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708529" y="112448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461732" y="273703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90761" y="2360631"/>
            <a:ext cx="8050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800" dirty="0" err="1" smtClean="0"/>
              <a:t>Retnl</a:t>
            </a:r>
            <a:r>
              <a:rPr lang="en-GB" sz="800" dirty="0" err="1" smtClean="0">
                <a:latin typeface="Symbol" panose="05050102010706020507" pitchFamily="18" charset="2"/>
              </a:rPr>
              <a:t>g</a:t>
            </a:r>
            <a:r>
              <a:rPr lang="en-GB" sz="800" dirty="0" smtClean="0">
                <a:latin typeface="Symbol" panose="05050102010706020507" pitchFamily="18" charset="2"/>
              </a:rPr>
              <a:t> (</a:t>
            </a:r>
            <a:r>
              <a:rPr lang="en-GB" sz="800" dirty="0" smtClean="0">
                <a:latin typeface="+mj-lt"/>
              </a:rPr>
              <a:t>738bp</a:t>
            </a:r>
            <a:r>
              <a:rPr lang="en-GB" sz="800" dirty="0" smtClean="0">
                <a:latin typeface="Symbol" panose="05050102010706020507" pitchFamily="18" charset="2"/>
              </a:rPr>
              <a:t>)</a:t>
            </a:r>
            <a:endParaRPr lang="en-GB" sz="800" dirty="0">
              <a:latin typeface="Symbol" panose="05050102010706020507" pitchFamily="18" charset="2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77660" y="2109914"/>
            <a:ext cx="715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800" dirty="0" smtClean="0"/>
              <a:t>Ccr3 (730bp)</a:t>
            </a:r>
            <a:endParaRPr lang="en-GB" sz="800" dirty="0"/>
          </a:p>
        </p:txBody>
      </p:sp>
      <p:sp>
        <p:nvSpPr>
          <p:cNvPr id="35" name="TextBox 34"/>
          <p:cNvSpPr txBox="1"/>
          <p:nvPr/>
        </p:nvSpPr>
        <p:spPr>
          <a:xfrm>
            <a:off x="662627" y="2817504"/>
            <a:ext cx="8996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Analysed CpG</a:t>
            </a:r>
            <a:endParaRPr lang="en-GB" sz="1000" dirty="0"/>
          </a:p>
        </p:txBody>
      </p:sp>
      <p:cxnSp>
        <p:nvCxnSpPr>
          <p:cNvPr id="36" name="Straight Connector 35"/>
          <p:cNvCxnSpPr/>
          <p:nvPr/>
        </p:nvCxnSpPr>
        <p:spPr>
          <a:xfrm flipH="1" flipV="1">
            <a:off x="584277" y="2875534"/>
            <a:ext cx="0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488357" y="2980541"/>
            <a:ext cx="2135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457052" y="295675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*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57947" y="3037224"/>
            <a:ext cx="1109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Not analysed CpG</a:t>
            </a:r>
            <a:endParaRPr lang="en-GB" sz="1000" dirty="0"/>
          </a:p>
        </p:txBody>
      </p:sp>
      <p:cxnSp>
        <p:nvCxnSpPr>
          <p:cNvPr id="40" name="Straight Connector 39"/>
          <p:cNvCxnSpPr/>
          <p:nvPr/>
        </p:nvCxnSpPr>
        <p:spPr>
          <a:xfrm flipH="1" flipV="1">
            <a:off x="579597" y="3095254"/>
            <a:ext cx="0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83677" y="3200261"/>
            <a:ext cx="2135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304465" y="2258743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210865" y="2261974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</a:rPr>
              <a:t>*</a:t>
            </a:r>
          </a:p>
        </p:txBody>
      </p:sp>
      <p:cxnSp>
        <p:nvCxnSpPr>
          <p:cNvPr id="44" name="Straight Connector 43"/>
          <p:cNvCxnSpPr/>
          <p:nvPr/>
        </p:nvCxnSpPr>
        <p:spPr>
          <a:xfrm flipH="1" flipV="1">
            <a:off x="1044858" y="2498375"/>
            <a:ext cx="5313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 flipV="1">
            <a:off x="5328858" y="2390586"/>
            <a:ext cx="0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 flipV="1">
            <a:off x="4428858" y="2390586"/>
            <a:ext cx="0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 flipV="1">
            <a:off x="3276858" y="2390586"/>
            <a:ext cx="0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 flipV="1">
            <a:off x="4335258" y="2390586"/>
            <a:ext cx="0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3152696" y="2253827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*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211893" y="225582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*</a:t>
            </a:r>
          </a:p>
        </p:txBody>
      </p:sp>
      <p:grpSp>
        <p:nvGrpSpPr>
          <p:cNvPr id="51" name="Group 50"/>
          <p:cNvGrpSpPr/>
          <p:nvPr/>
        </p:nvGrpSpPr>
        <p:grpSpPr>
          <a:xfrm>
            <a:off x="1051682" y="1970311"/>
            <a:ext cx="5256000" cy="251493"/>
            <a:chOff x="1080000" y="1888572"/>
            <a:chExt cx="5256000" cy="251493"/>
          </a:xfrm>
        </p:grpSpPr>
        <p:sp>
          <p:nvSpPr>
            <p:cNvPr id="52" name="TextBox 51"/>
            <p:cNvSpPr txBox="1"/>
            <p:nvPr/>
          </p:nvSpPr>
          <p:spPr>
            <a:xfrm>
              <a:off x="4663607" y="1893844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119214" y="1888572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grpSp>
          <p:nvGrpSpPr>
            <p:cNvPr id="54" name="Group 53"/>
            <p:cNvGrpSpPr/>
            <p:nvPr/>
          </p:nvGrpSpPr>
          <p:grpSpPr>
            <a:xfrm flipH="1" flipV="1">
              <a:off x="1080000" y="2027071"/>
              <a:ext cx="5256000" cy="108826"/>
              <a:chOff x="1260000" y="1656000"/>
              <a:chExt cx="5256000" cy="108826"/>
            </a:xfrm>
          </p:grpSpPr>
          <p:cxnSp>
            <p:nvCxnSpPr>
              <p:cNvPr id="56" name="Straight Connector 55"/>
              <p:cNvCxnSpPr/>
              <p:nvPr/>
            </p:nvCxnSpPr>
            <p:spPr>
              <a:xfrm>
                <a:off x="1260000" y="1656000"/>
                <a:ext cx="525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/>
              <p:cNvCxnSpPr/>
              <p:nvPr/>
            </p:nvCxnSpPr>
            <p:spPr>
              <a:xfrm>
                <a:off x="1425600" y="1657104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>
                <a:off x="2808000" y="1657104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>
                <a:off x="6350400" y="1657104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/>
            <p:cNvSpPr txBox="1"/>
            <p:nvPr/>
          </p:nvSpPr>
          <p:spPr>
            <a:xfrm>
              <a:off x="6052831" y="1891416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*</a:t>
              </a:r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1044858" y="1452640"/>
            <a:ext cx="5428800" cy="264799"/>
            <a:chOff x="1080000" y="1370901"/>
            <a:chExt cx="5428800" cy="264799"/>
          </a:xfrm>
        </p:grpSpPr>
        <p:sp>
          <p:nvSpPr>
            <p:cNvPr id="61" name="TextBox 60"/>
            <p:cNvSpPr txBox="1"/>
            <p:nvPr/>
          </p:nvSpPr>
          <p:spPr>
            <a:xfrm>
              <a:off x="4341067" y="1370901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grpSp>
          <p:nvGrpSpPr>
            <p:cNvPr id="62" name="Group 61"/>
            <p:cNvGrpSpPr/>
            <p:nvPr/>
          </p:nvGrpSpPr>
          <p:grpSpPr>
            <a:xfrm>
              <a:off x="1080000" y="1514484"/>
              <a:ext cx="5428800" cy="107722"/>
              <a:chOff x="1080000" y="1440000"/>
              <a:chExt cx="5428800" cy="107722"/>
            </a:xfrm>
          </p:grpSpPr>
          <p:cxnSp>
            <p:nvCxnSpPr>
              <p:cNvPr id="68" name="Straight Connector 67"/>
              <p:cNvCxnSpPr/>
              <p:nvPr/>
            </p:nvCxnSpPr>
            <p:spPr>
              <a:xfrm flipH="1" flipV="1">
                <a:off x="1080000" y="1543450"/>
                <a:ext cx="54288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flipH="1" flipV="1">
                <a:off x="5601600" y="1440000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 flipH="1" flipV="1">
                <a:off x="4464000" y="1440000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 flipH="1" flipV="1">
                <a:off x="2044800" y="1440000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 flipH="1" flipV="1">
                <a:off x="1346400" y="1440000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flipH="1" flipV="1">
                <a:off x="1368000" y="1440000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 flipH="1" flipV="1">
                <a:off x="4190400" y="1440000"/>
                <a:ext cx="0" cy="10772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" name="TextBox 62"/>
            <p:cNvSpPr txBox="1"/>
            <p:nvPr/>
          </p:nvSpPr>
          <p:spPr>
            <a:xfrm>
              <a:off x="5485159" y="1377725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066007" y="1376716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219571" y="1389479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*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246897" y="1387849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*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916011" y="1389479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*</a:t>
              </a:r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1044785" y="1700424"/>
            <a:ext cx="4410842" cy="263051"/>
            <a:chOff x="1059455" y="1618685"/>
            <a:chExt cx="4410842" cy="263051"/>
          </a:xfrm>
        </p:grpSpPr>
        <p:grpSp>
          <p:nvGrpSpPr>
            <p:cNvPr id="76" name="Group 75"/>
            <p:cNvGrpSpPr/>
            <p:nvPr/>
          </p:nvGrpSpPr>
          <p:grpSpPr>
            <a:xfrm>
              <a:off x="1059455" y="1618685"/>
              <a:ext cx="4356000" cy="250366"/>
              <a:chOff x="1079927" y="1618685"/>
              <a:chExt cx="4356000" cy="250366"/>
            </a:xfrm>
          </p:grpSpPr>
          <p:grpSp>
            <p:nvGrpSpPr>
              <p:cNvPr id="79" name="Group 78"/>
              <p:cNvGrpSpPr/>
              <p:nvPr/>
            </p:nvGrpSpPr>
            <p:grpSpPr>
              <a:xfrm>
                <a:off x="1079927" y="1758888"/>
                <a:ext cx="4356000" cy="107789"/>
                <a:chOff x="1079927" y="1916132"/>
                <a:chExt cx="4356000" cy="107789"/>
              </a:xfrm>
            </p:grpSpPr>
            <p:cxnSp>
              <p:nvCxnSpPr>
                <p:cNvPr id="83" name="Straight Connector 82"/>
                <p:cNvCxnSpPr/>
                <p:nvPr/>
              </p:nvCxnSpPr>
              <p:spPr>
                <a:xfrm flipH="1" flipV="1">
                  <a:off x="1079927" y="2023921"/>
                  <a:ext cx="435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Straight Connector 83"/>
                <p:cNvCxnSpPr/>
                <p:nvPr/>
              </p:nvCxnSpPr>
              <p:spPr>
                <a:xfrm flipH="1" flipV="1">
                  <a:off x="5366600" y="1916132"/>
                  <a:ext cx="0" cy="1077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/>
                <p:cNvCxnSpPr/>
                <p:nvPr/>
              </p:nvCxnSpPr>
              <p:spPr>
                <a:xfrm flipH="1" flipV="1">
                  <a:off x="4423400" y="1916132"/>
                  <a:ext cx="0" cy="1077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85"/>
                <p:cNvCxnSpPr/>
                <p:nvPr/>
              </p:nvCxnSpPr>
              <p:spPr>
                <a:xfrm flipH="1" flipV="1">
                  <a:off x="2429000" y="1916132"/>
                  <a:ext cx="0" cy="1077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/>
                <p:cNvCxnSpPr/>
                <p:nvPr/>
              </p:nvCxnSpPr>
              <p:spPr>
                <a:xfrm flipH="1" flipV="1">
                  <a:off x="2162600" y="1916132"/>
                  <a:ext cx="0" cy="1077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87"/>
                <p:cNvCxnSpPr/>
                <p:nvPr/>
              </p:nvCxnSpPr>
              <p:spPr>
                <a:xfrm flipH="1" flipV="1">
                  <a:off x="3429800" y="1916132"/>
                  <a:ext cx="0" cy="1077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0" name="TextBox 79"/>
              <p:cNvSpPr txBox="1"/>
              <p:nvPr/>
            </p:nvSpPr>
            <p:spPr>
              <a:xfrm>
                <a:off x="2037373" y="1618685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2304607" y="1619818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solidFill>
                      <a:srgbClr val="FF0000"/>
                    </a:solidFill>
                  </a:rPr>
                  <a:t>*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301069" y="1622830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/>
                  <a:t>*</a:t>
                </a:r>
              </a:p>
            </p:txBody>
          </p:sp>
        </p:grpSp>
        <p:sp>
          <p:nvSpPr>
            <p:cNvPr id="77" name="TextBox 76"/>
            <p:cNvSpPr txBox="1"/>
            <p:nvPr/>
          </p:nvSpPr>
          <p:spPr>
            <a:xfrm>
              <a:off x="4274139" y="1627151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*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221511" y="1635515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/>
                <a:t>*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457052" y="3584672"/>
            <a:ext cx="632521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Additional file 5. </a:t>
            </a:r>
            <a:r>
              <a:rPr lang="en-GB" sz="1000" b="1" smtClean="0"/>
              <a:t>Position of the </a:t>
            </a:r>
            <a:r>
              <a:rPr lang="en-GB" sz="1000" b="1" dirty="0" smtClean="0"/>
              <a:t>analysed and not analysed </a:t>
            </a:r>
            <a:r>
              <a:rPr lang="en-GB" sz="1000" b="1" dirty="0" smtClean="0"/>
              <a:t>CpGs </a:t>
            </a:r>
            <a:r>
              <a:rPr lang="en-GB" sz="1000" b="1" dirty="0" smtClean="0"/>
              <a:t>in the promoter regions of the genes selected for pyrosequencing analysis. </a:t>
            </a:r>
            <a:r>
              <a:rPr lang="en-GB" sz="1000" dirty="0" smtClean="0"/>
              <a:t>For none of the analysed positions a significant difference in methylation between males and females was detected (p in all cases&gt; 0.01).</a:t>
            </a:r>
          </a:p>
          <a:p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992067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11</TotalTime>
  <Words>106</Words>
  <Application>Microsoft Office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egenga, Wilma</dc:creator>
  <cp:lastModifiedBy>Steegenga, Wilma</cp:lastModifiedBy>
  <cp:revision>262</cp:revision>
  <cp:lastPrinted>2014-07-08T11:42:54Z</cp:lastPrinted>
  <dcterms:created xsi:type="dcterms:W3CDTF">2013-09-10T04:43:47Z</dcterms:created>
  <dcterms:modified xsi:type="dcterms:W3CDTF">2014-07-29T10:33:49Z</dcterms:modified>
</cp:coreProperties>
</file>